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8" d="100"/>
          <a:sy n="88" d="100"/>
        </p:scale>
        <p:origin x="120" y="4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BACF27-ADF1-4D49-9CBB-B41B0598DD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4866176-2F4C-4872-BF26-1DE22C4954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44EEE6-7477-48E4-A796-8911446F2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436CAA2-BBD1-45E3-9F1E-5FF27DF06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BBC6295-1D76-49DA-8836-968754EFB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1371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6290D4-33E7-41BA-BDA7-739AD2C3DE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2DA5FE0-67C7-4866-8835-6E1F36783F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45C1440-2180-40B5-AAD6-E397FEADD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ADE5E0-008A-4DAA-A547-AA56F7FBA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AC4FCC-644D-4441-B7AE-3005D6493F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9261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EC2DF19-3212-408E-935A-A14D38FD36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0846393-6DC0-4E32-BE67-56ED8966CD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2BB922-89E8-4913-84BF-6D9C24E7B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988DC8-1C95-4494-BF7A-FA6CD28FA6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86CB26-6198-463F-9340-17834F8D7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3720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702DCA-1151-41F6-96FD-E18B9B2455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9B46C43-B945-4769-81FC-D998A27459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FE46B8-22EC-4858-AD6F-C4769B59CD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1DBFC8-101C-4523-819E-004D2151D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F584F5-B623-4828-93F4-85AFD0473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6845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B59DE3-0D7A-42A7-B45E-5C610E434B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CA5F9DF-4842-46D7-A41B-CD59378E39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D9F1C6-48AC-4FBB-8C06-721DC2DC7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ACDE63A-8D83-49B1-B837-F5B9C356D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9052A8-9EBB-4DA0-87FB-62651CA81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1909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E9F6E5-C3A1-49F7-A558-7B90301C53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170C94F-6442-48F3-AF0F-1311635F5F4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846B7F1-4BAF-4744-8068-76698D993F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8C12656-26E3-4FB5-99FB-61ABCAC32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CF4E341-C090-44E7-8E82-E8F740AFE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0A19450-BEFB-4914-9161-C87736721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6056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5071A8-C8EB-4B38-B4AA-8BC10659C7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44C203F-6432-4EFB-91A8-900D74EE1E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9B80330-0893-4BD1-B65F-23290263EB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5B5C5F8-F3BE-420F-AB9B-16446A0315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3177805-1277-4535-8CA8-C7C42CCD23D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0684DC8-164F-4B5D-A413-97A00E41D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4C4B7EE-D14A-40EB-BA48-66E3BDF75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27E33A0-2D4A-4038-AF20-4A5C5F8BAE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8123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76D3B9-E411-48A3-8F09-F241A6C2C9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9EDDF8E-DD2A-4A95-99B6-799829DB8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9F1CB6C-EB0B-45E3-819C-1B2F15E531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18E5345-F83D-45B9-88BF-3362C8EEE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6279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4A008E8-C78B-4E9E-82FB-6AFD6464F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6D36D8A-A5DD-4BC1-B8F1-940F2EB7C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362FDDB-D379-4D01-A913-A2C6898DA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292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3E355B-1D94-4AA9-A0F1-33CD3E9BAE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0A68DE-A806-4270-AB74-4A16C1C82B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5406929-4D90-4061-8060-CF9CA638C8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154910C-401E-4D2C-9579-2C8091770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CBF8218-3A95-4A3C-8AE8-9B0F2C0A5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2E221D-2263-4123-B7C4-DF4381851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0496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E1DC03-38AD-409A-94FC-FD11ACB1B9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35BF58B-28D9-4C83-BEE6-5E54F21369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8D334E3-BDF7-4A87-999B-A8B5ABBC1D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92FD2D1-2C6D-473F-A4ED-3173B53FA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668ED5-C754-436D-9E8C-5C5281947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CD629A6-C1B0-4D55-9281-97FDAFB59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0497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2877127-B91B-4A2E-9245-079C86E07D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9AC6E03-735B-4FFD-85FE-8D9705F9C6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39CDAF-BCA1-4FF4-A0E0-AACCCC82A5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1A9DF-167F-47D3-9D81-85C6CA06DD42}" type="datetimeFigureOut">
              <a:rPr lang="zh-CN" altLang="en-US" smtClean="0"/>
              <a:t>2021-11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0C6907-C620-4B72-8386-A876BBE456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E0B829-3B12-4E97-9420-F9564C3998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7B1B19-B9FA-4585-890B-6AC6604BED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4775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8B9D4C2-995C-488B-A66D-64FBD9FA78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4848" y="551688"/>
            <a:ext cx="6242304" cy="575462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A8E560A8-A34C-4740-A6C9-D06956FC1E2B}"/>
              </a:ext>
            </a:extLst>
          </p:cNvPr>
          <p:cNvSpPr txBox="1"/>
          <p:nvPr/>
        </p:nvSpPr>
        <p:spPr>
          <a:xfrm>
            <a:off x="413656" y="6306312"/>
            <a:ext cx="116041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relative abundance of microbial eukaryote and metazoan (A) and community structure of the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zoa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the level of subgroup (B) in the sediment samples collected from the northern South China Sea. The numbers 1, 2 and 3 represent the 0-2 cm, 2-4 cm, and 4-6 cm sediment layers, respectively.</a:t>
            </a:r>
            <a:endParaRPr lang="zh-CN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12347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99D5E93-59F3-4B2F-A192-34D0FF0015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9232" y="729996"/>
            <a:ext cx="6193536" cy="539800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04431C1-48C6-449A-8E5D-BF6372A6D4AC}"/>
              </a:ext>
            </a:extLst>
          </p:cNvPr>
          <p:cNvSpPr txBox="1"/>
          <p:nvPr/>
        </p:nvSpPr>
        <p:spPr>
          <a:xfrm>
            <a:off x="1262743" y="6128004"/>
            <a:ext cx="90024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atmap showing the relative abundance of different clades affiliated to the parasitic 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diniale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sediment samples collected from the northern South China Sea.</a:t>
            </a:r>
            <a:endParaRPr lang="zh-CN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3750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89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isi</dc:creator>
  <cp:lastModifiedBy>sisi</cp:lastModifiedBy>
  <cp:revision>1</cp:revision>
  <dcterms:created xsi:type="dcterms:W3CDTF">2021-11-29T10:19:48Z</dcterms:created>
  <dcterms:modified xsi:type="dcterms:W3CDTF">2021-11-29T10:24:42Z</dcterms:modified>
</cp:coreProperties>
</file>